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69" r:id="rId3"/>
    <p:sldId id="270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0" d="100"/>
          <a:sy n="80" d="100"/>
        </p:scale>
        <p:origin x="778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4553A3A-2CE6-164C-0F41-FB19AAB7E4B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0282E2CE-ECD5-AF7C-288A-BE9E1346A51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076D6C1-1D86-DAC8-2693-354582445B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1C0FF0-7751-43F1-A0F4-C8451EA9E733}" type="datetimeFigureOut">
              <a:rPr lang="zh-CN" altLang="en-US" smtClean="0"/>
              <a:t>2023/9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3C5611C-56F6-6114-6779-D0AEBAAB65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4B2164E-7C5D-BC95-23B3-3F08B439CD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35B00-F8A6-4322-B655-7E825F5B63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284549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A1B189E-817C-F7DA-098E-F786523691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4884C3D-843B-42F8-2E4C-9297C84FC3D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7C2AC01-9A5D-98D1-0391-1D12343D4C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1C0FF0-7751-43F1-A0F4-C8451EA9E733}" type="datetimeFigureOut">
              <a:rPr lang="zh-CN" altLang="en-US" smtClean="0"/>
              <a:t>2023/9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69A8A7F-70F9-9785-7635-09D7F08201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CE8F5B5-B30D-B025-3FF7-2914AFEF62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35B00-F8A6-4322-B655-7E825F5B63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21712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B993D8A1-E609-AB30-AE23-F70F0EB50FB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D620015-736E-68E6-1C34-562C4CE5E45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3F95BC3-7D9C-521A-25E2-82DB23FF7B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1C0FF0-7751-43F1-A0F4-C8451EA9E733}" type="datetimeFigureOut">
              <a:rPr lang="zh-CN" altLang="en-US" smtClean="0"/>
              <a:t>2023/9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9968183-20DC-2D53-01A1-76DED3E397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030818F-38C6-A815-1DC2-688E6A350A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35B00-F8A6-4322-B655-7E825F5B63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38517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20348A8-5EF5-0521-6349-A2587F9522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4BA072D-8E9E-24A4-EC3A-F13B3DB67CB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C17D41E-C8B7-22E8-BA6E-6E50EDBF27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1C0FF0-7751-43F1-A0F4-C8451EA9E733}" type="datetimeFigureOut">
              <a:rPr lang="zh-CN" altLang="en-US" smtClean="0"/>
              <a:t>2023/9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0B70A33-C3EE-E51E-6211-100DE462B2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4014AFD-9E67-7D81-C3E5-2BFCBF3E09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35B00-F8A6-4322-B655-7E825F5B63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495524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83BE879-E5BA-EE6B-621B-EA4C5B9EB4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E0D17A8-2F20-EE31-6A28-2E82F13B7B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2FE98A8-D833-EE03-0F56-F2E4DA786D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1C0FF0-7751-43F1-A0F4-C8451EA9E733}" type="datetimeFigureOut">
              <a:rPr lang="zh-CN" altLang="en-US" smtClean="0"/>
              <a:t>2023/9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898C0AC-3D0E-3A2B-F6B7-9C4EC1A40E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47A8775-1A7D-0393-41F1-D7CA68B459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35B00-F8A6-4322-B655-7E825F5B63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321456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8266665-2A92-66BF-6D3C-63452B804C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62F1C05-27EA-9EC4-5018-9636425E9DF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EAE2B51-FF82-1C03-4897-0E8393A447A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46B3130-2013-9DAC-F60A-E623059867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1C0FF0-7751-43F1-A0F4-C8451EA9E733}" type="datetimeFigureOut">
              <a:rPr lang="zh-CN" altLang="en-US" smtClean="0"/>
              <a:t>2023/9/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FAB7670-C3C2-F8EA-8D51-197213CD98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FE23FF6-71B4-FB6E-333C-46B8A9488C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35B00-F8A6-4322-B655-7E825F5B63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656544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8AB31C7-1945-3D0F-390A-382ABB9D3A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C2D2A99-ABC2-7C87-07EE-5D74112200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9BF7778-E500-E480-EA19-BF1FE61B7DC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877261AE-30EA-FF6E-2A95-43F8BCA86CB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727D0352-3729-55E6-CD41-56B4D918229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60DCFBB8-CF66-FC5F-EABB-195B2295C0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1C0FF0-7751-43F1-A0F4-C8451EA9E733}" type="datetimeFigureOut">
              <a:rPr lang="zh-CN" altLang="en-US" smtClean="0"/>
              <a:t>2023/9/23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DC993B7B-1677-71B4-C7F0-AFB88E89D7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53B6DEA6-94BC-5C27-7773-8AC1954D41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35B00-F8A6-4322-B655-7E825F5B63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403498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4B0B099-CFC3-9024-C8F7-0C5649BFF6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00FD6934-ACF2-61CF-1A10-31A9153EBB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1C0FF0-7751-43F1-A0F4-C8451EA9E733}" type="datetimeFigureOut">
              <a:rPr lang="zh-CN" altLang="en-US" smtClean="0"/>
              <a:t>2023/9/23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BEC6C7DC-7EA1-D82C-653A-0C0891096D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C4A799C2-CB51-DB74-2020-E9DF45FB3B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35B00-F8A6-4322-B655-7E825F5B63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6431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9E78909F-7A1F-E8F8-A0B6-3F69E5E046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1C0FF0-7751-43F1-A0F4-C8451EA9E733}" type="datetimeFigureOut">
              <a:rPr lang="zh-CN" altLang="en-US" smtClean="0"/>
              <a:t>2023/9/23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CB61D407-DEB2-948E-5F7D-6101AD524A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C13EBBC9-445B-F181-9166-87E5EA7359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35B00-F8A6-4322-B655-7E825F5B63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905924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9856C7D-9AD6-6132-1B0D-D07B10BD14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4FABB22-B38A-6349-4B1C-C8861ED3BDD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BFA9945-264F-A510-7587-DA573F42FB1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52BAD63-C066-2AF2-1023-0376ABB0DF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1C0FF0-7751-43F1-A0F4-C8451EA9E733}" type="datetimeFigureOut">
              <a:rPr lang="zh-CN" altLang="en-US" smtClean="0"/>
              <a:t>2023/9/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43E0CE6-A986-69D4-3D4C-E44DA60C3D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B266E5C-0EB3-6C91-6214-722EAA5DC4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35B00-F8A6-4322-B655-7E825F5B63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28894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1225A97-F7C8-8134-BE40-6661E86B09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F330D480-28BF-8BFD-ABCB-673DCDA1F3C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6AFF592-CB21-EFDA-6345-EE947958F1C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9AE149D-5985-5F50-0C1F-5C76E791E0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1C0FF0-7751-43F1-A0F4-C8451EA9E733}" type="datetimeFigureOut">
              <a:rPr lang="zh-CN" altLang="en-US" smtClean="0"/>
              <a:t>2023/9/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9916673-75C7-C433-FE9F-7016ADA565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6FFEBC0-C259-E9A0-5C0F-0FA949CDD4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35B00-F8A6-4322-B655-7E825F5B63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59455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67481B6B-C67F-2564-1A35-4F891096F6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C92E537-4328-DACC-383F-30DCDD3C79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76E4A04-60BF-1805-733B-9DB45FA3ACC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1C0FF0-7751-43F1-A0F4-C8451EA9E733}" type="datetimeFigureOut">
              <a:rPr lang="zh-CN" altLang="en-US" smtClean="0"/>
              <a:t>2023/9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7B5B0D0-A12B-2216-72E7-04B3FEE3F0C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ED81FEA-4BA8-4049-C5FD-96757E1C728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E35B00-F8A6-4322-B655-7E825F5B63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194364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38AE19A3-651F-A25F-AA6D-BDA80CF8B59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69335" y="654787"/>
            <a:ext cx="8053330" cy="4115595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FFFCB830-76EB-A8CD-4054-21E65D096475}"/>
              </a:ext>
            </a:extLst>
          </p:cNvPr>
          <p:cNvSpPr txBox="1"/>
          <p:nvPr/>
        </p:nvSpPr>
        <p:spPr>
          <a:xfrm>
            <a:off x="-1267552" y="5145655"/>
            <a:ext cx="13792199" cy="14080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altLang="zh-CN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A1.</a:t>
            </a:r>
            <a:r>
              <a:rPr lang="en-US" altLang="zh-CN" sz="1800" b="1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Verification of </a:t>
            </a:r>
            <a:r>
              <a:rPr lang="en-US" altLang="zh-CN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mWRI14-like</a:t>
            </a:r>
            <a:r>
              <a:rPr lang="en-US" altLang="zh-CN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expression in T0/T1 transgenic soybeans using Southern blot analysis. (A) </a:t>
            </a:r>
            <a:r>
              <a:rPr lang="en-US" altLang="zh-CN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he </a:t>
            </a:r>
            <a:r>
              <a:rPr lang="en-US" altLang="zh-CN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mWRI14-like</a:t>
            </a:r>
            <a:r>
              <a:rPr lang="en-US" altLang="zh-CN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gene was cloned into the </a:t>
            </a:r>
            <a:r>
              <a:rPr lang="en-US" altLang="zh-CN" sz="1800" i="1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amHI-SacI</a:t>
            </a:r>
            <a:r>
              <a:rPr lang="en-US" altLang="zh-CN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site of plasmid </a:t>
            </a:r>
            <a:r>
              <a:rPr lang="en-US" altLang="zh-CN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TF101</a:t>
            </a:r>
            <a:r>
              <a:rPr lang="en-US" altLang="zh-CN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named </a:t>
            </a:r>
            <a:r>
              <a:rPr lang="en-US" altLang="zh-CN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TF101- GmWRI14-3</a:t>
            </a:r>
            <a:r>
              <a:rPr lang="zh-CN" altLang="zh-CN" sz="1800" i="1" dirty="0">
                <a:solidFill>
                  <a:srgbClr val="000000"/>
                </a:solidFill>
                <a:effectLst/>
                <a:ea typeface="宋体" panose="02010600030101010101" pitchFamily="2" charset="-122"/>
                <a:cs typeface="宋体" panose="02010600030101010101" pitchFamily="2" charset="-122"/>
              </a:rPr>
              <a:t>×</a:t>
            </a:r>
            <a:r>
              <a:rPr lang="en-US" altLang="zh-CN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lag</a:t>
            </a:r>
            <a:r>
              <a:rPr lang="en-US" altLang="zh-CN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which induced by the </a:t>
            </a:r>
            <a:r>
              <a:rPr lang="en-US" altLang="zh-CN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aMV35S </a:t>
            </a:r>
            <a:r>
              <a:rPr lang="en-US" altLang="zh-CN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romoter, and the target gene was terminated by the </a:t>
            </a:r>
            <a:r>
              <a:rPr lang="en-US" altLang="zh-CN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OS</a:t>
            </a:r>
            <a:r>
              <a:rPr lang="en-US" altLang="zh-CN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terminator</a:t>
            </a:r>
            <a:r>
              <a:rPr lang="en-US" altLang="zh-CN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zh-CN" altLang="en-US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B) Southern blot analysis of the copy number of the </a:t>
            </a:r>
            <a:r>
              <a:rPr lang="en-US" altLang="zh-CN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mWRI14</a:t>
            </a:r>
            <a:r>
              <a:rPr lang="en-US" altLang="zh-CN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expression cassette in T0 plants. Copy number of the </a:t>
            </a:r>
            <a:r>
              <a:rPr lang="en-US" altLang="zh-CN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mWRI14</a:t>
            </a:r>
            <a:r>
              <a:rPr lang="en-US" altLang="zh-CN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expression cassette in T1 plants. P: positive control. C: control </a:t>
            </a:r>
            <a:r>
              <a:rPr lang="en-US" altLang="zh-CN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roup</a:t>
            </a:r>
            <a:r>
              <a:rPr lang="en-US" altLang="zh-CN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M: marker. </a:t>
            </a:r>
            <a:endParaRPr lang="zh-CN" altLang="zh-CN" sz="18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748864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FE0B721B-5524-B6E1-D361-6DB1A91E4187}"/>
              </a:ext>
            </a:extLst>
          </p:cNvPr>
          <p:cNvSpPr txBox="1"/>
          <p:nvPr/>
        </p:nvSpPr>
        <p:spPr>
          <a:xfrm>
            <a:off x="-1362802" y="5869555"/>
            <a:ext cx="13792199" cy="88178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altLang="zh-CN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A2.</a:t>
            </a:r>
            <a:r>
              <a:rPr lang="en-US" altLang="zh-CN" sz="1800" b="1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altLang="zh-CN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aps of CRISPR/Cas9 vectors, which induced by the pM4</a:t>
            </a:r>
            <a:r>
              <a:rPr lang="en-US" altLang="zh-CN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romoter</a:t>
            </a:r>
            <a:r>
              <a:rPr lang="en-US" altLang="zh-CN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zh-CN" altLang="en-US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zh-CN" altLang="en-US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（</a:t>
            </a:r>
            <a:r>
              <a:rPr lang="en-US" altLang="zh-CN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zh-CN" altLang="en-US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）</a:t>
            </a:r>
            <a:r>
              <a:rPr lang="en-US" altLang="zh-CN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ositions of three targets in the </a:t>
            </a:r>
            <a:r>
              <a:rPr lang="en-US" altLang="zh-CN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mWRI14-like</a:t>
            </a:r>
            <a:r>
              <a:rPr lang="en-US" altLang="zh-CN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gene locus, the white boxes on the left and the right represent 5' and 3' noncoding regions; the black box stands for CDS. (C) </a:t>
            </a:r>
            <a:r>
              <a:rPr lang="en-US" altLang="zh-CN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quence alignment analysis between </a:t>
            </a:r>
            <a:r>
              <a:rPr lang="en-US" altLang="zh-CN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mwri14-like</a:t>
            </a:r>
            <a:r>
              <a:rPr lang="en-US" altLang="zh-CN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utant and wild-type</a:t>
            </a:r>
            <a:endParaRPr lang="zh-CN" altLang="zh-CN" sz="18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975DE6C5-3C84-1BB6-6615-0086CBDC3F6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87286" y="469181"/>
            <a:ext cx="9446711" cy="54003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3450126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90B814D2-F29C-D633-93FD-109ED3B39323}"/>
              </a:ext>
            </a:extLst>
          </p:cNvPr>
          <p:cNvPicPr/>
          <p:nvPr/>
        </p:nvPicPr>
        <p:blipFill>
          <a:blip r:embed="rId2" cstate="print"/>
          <a:srcRect/>
          <a:stretch>
            <a:fillRect/>
          </a:stretch>
        </p:blipFill>
        <p:spPr>
          <a:xfrm>
            <a:off x="2476500" y="371475"/>
            <a:ext cx="7372350" cy="4933949"/>
          </a:xfrm>
          <a:prstGeom prst="rect">
            <a:avLst/>
          </a:prstGeom>
          <a:ln>
            <a:noFill/>
          </a:ln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CCFFC4B3-DA20-0B72-70BB-EEDEDC18C3CD}"/>
              </a:ext>
            </a:extLst>
          </p:cNvPr>
          <p:cNvSpPr txBox="1"/>
          <p:nvPr/>
        </p:nvSpPr>
        <p:spPr>
          <a:xfrm>
            <a:off x="-1447873" y="5436327"/>
            <a:ext cx="13792199" cy="11449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altLang="zh-CN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A3.</a:t>
            </a:r>
            <a:r>
              <a:rPr lang="en-US" altLang="zh-CN" sz="1800" b="1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amino acid sequence encoded by </a:t>
            </a:r>
            <a:r>
              <a:rPr lang="en-US" altLang="zh-CN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lyma.04G116500.1 </a:t>
            </a:r>
            <a:r>
              <a:rPr lang="en-US" altLang="zh-CN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as compared with </a:t>
            </a:r>
            <a:r>
              <a:rPr lang="en-US" altLang="zh-CN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WRI1</a:t>
            </a:r>
            <a:r>
              <a:rPr lang="en-US" altLang="zh-CN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Gene ID:824599), the homology of the amino acid sequences between </a:t>
            </a:r>
            <a:r>
              <a:rPr lang="en-US" altLang="zh-CN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lyma.04G116500.1 </a:t>
            </a:r>
            <a:r>
              <a:rPr lang="en-US" altLang="zh-CN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zh-CN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WRI1</a:t>
            </a:r>
            <a:r>
              <a:rPr lang="en-US" altLang="zh-CN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s 62.34%. A multiple alignment showed that </a:t>
            </a:r>
            <a:r>
              <a:rPr lang="en-US" altLang="zh-CN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lyma.04G116500.1 </a:t>
            </a:r>
            <a:r>
              <a:rPr lang="en-US" altLang="zh-CN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ntained two (AP2/EREB) DNA-binding domains, which were located at positions 54 to 220 of the amino acid sequence </a:t>
            </a:r>
            <a:endParaRPr lang="zh-CN" altLang="zh-CN" sz="18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515516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23</TotalTime>
  <Words>239</Words>
  <Application>Microsoft Office PowerPoint</Application>
  <PresentationFormat>宽屏</PresentationFormat>
  <Paragraphs>3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等线</vt:lpstr>
      <vt:lpstr>等线 Light</vt:lpstr>
      <vt:lpstr>Arial</vt:lpstr>
      <vt:lpstr>Palatino Linotype</vt:lpstr>
      <vt:lpstr>Office 主题​​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Qin Di</dc:creator>
  <cp:lastModifiedBy>Di Qin</cp:lastModifiedBy>
  <cp:revision>14</cp:revision>
  <dcterms:created xsi:type="dcterms:W3CDTF">2023-05-04T05:07:47Z</dcterms:created>
  <dcterms:modified xsi:type="dcterms:W3CDTF">2023-09-23T03:16:59Z</dcterms:modified>
</cp:coreProperties>
</file>